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57" r:id="rId4"/>
    <p:sldId id="261" r:id="rId5"/>
    <p:sldId id="262" r:id="rId6"/>
    <p:sldId id="267" r:id="rId7"/>
    <p:sldId id="265" r:id="rId8"/>
    <p:sldId id="266" r:id="rId9"/>
    <p:sldId id="269" r:id="rId10"/>
    <p:sldId id="268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f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ثالثة</a:t>
            </a:r>
          </a:p>
          <a:p>
            <a:r>
              <a:rPr lang="ar-SY" sz="3200" dirty="0"/>
              <a:t>تطبيق الدليل وتقويم العملية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C0E5A-635E-49A0-A456-696517286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مراجع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CD47E-CB2F-45EA-9A64-9C747DA529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 err="1"/>
              <a:t>Akobeng</a:t>
            </a:r>
            <a:r>
              <a:rPr lang="en-US" dirty="0"/>
              <a:t>, A. K. (2005). Principles of evidence based medicine. Archives of Disease in Childhood, 90(8), 837–840. https://doi.org/10.1136/adc.2005.071761</a:t>
            </a:r>
          </a:p>
          <a:p>
            <a:r>
              <a:rPr lang="en-US" dirty="0"/>
              <a:t>Charles, C., Gafni, A., &amp; Whelan, T. (1997). Shared decision-making in the medical encounter: what does it mean?(or it takes at least two to tango). Social Science &amp; Medicine, 44(5), 681–692.</a:t>
            </a:r>
          </a:p>
          <a:p>
            <a:r>
              <a:rPr lang="en-US" dirty="0"/>
              <a:t>Greenhalgh, T., Howick, J., &amp; </a:t>
            </a:r>
            <a:r>
              <a:rPr lang="en-US" dirty="0" err="1"/>
              <a:t>Maskrey</a:t>
            </a:r>
            <a:r>
              <a:rPr lang="en-US" dirty="0"/>
              <a:t>, N. (2014). Evidence based medicine: a movement in crisis? </a:t>
            </a:r>
            <a:r>
              <a:rPr lang="en-US" i="1" dirty="0" err="1"/>
              <a:t>Bmj</a:t>
            </a:r>
            <a:r>
              <a:rPr lang="en-US" dirty="0"/>
              <a:t>, </a:t>
            </a:r>
            <a:r>
              <a:rPr lang="en-US" i="1" dirty="0"/>
              <a:t>348</a:t>
            </a:r>
            <a:r>
              <a:rPr lang="en-US" dirty="0"/>
              <a:t>.</a:t>
            </a:r>
          </a:p>
          <a:p>
            <a:r>
              <a:rPr lang="en-US" dirty="0"/>
              <a:t>Kang, H. (2016). How to understand and conduct evidence-based medicine. </a:t>
            </a:r>
            <a:r>
              <a:rPr lang="en-US" i="1" dirty="0"/>
              <a:t>Korean Journal of Anesthesiology</a:t>
            </a:r>
            <a:r>
              <a:rPr lang="en-US" dirty="0"/>
              <a:t>, </a:t>
            </a:r>
            <a:r>
              <a:rPr lang="en-US" i="1" dirty="0"/>
              <a:t>69</a:t>
            </a:r>
            <a:r>
              <a:rPr lang="en-US" dirty="0"/>
              <a:t>(5), 435–445. https://doi.org/10.4097/kjae.2016.69.5.435</a:t>
            </a:r>
          </a:p>
          <a:p>
            <a:r>
              <a:rPr lang="en-US" dirty="0" err="1"/>
              <a:t>Karagiannis</a:t>
            </a:r>
            <a:r>
              <a:rPr lang="en-US" dirty="0"/>
              <a:t>, T. (2019). The importance of applying evidence-based medicine in clinical practice. In </a:t>
            </a:r>
            <a:r>
              <a:rPr lang="en-US" i="1" dirty="0"/>
              <a:t>Management of Hypertension</a:t>
            </a:r>
            <a:r>
              <a:rPr lang="en-US" dirty="0"/>
              <a:t> (pp. 3–17). Springer.</a:t>
            </a:r>
          </a:p>
          <a:p>
            <a:r>
              <a:rPr lang="en-US" dirty="0" err="1"/>
              <a:t>Stiggelbout</a:t>
            </a:r>
            <a:r>
              <a:rPr lang="en-US" dirty="0"/>
              <a:t>, A. M., Van der </a:t>
            </a:r>
            <a:r>
              <a:rPr lang="en-US" dirty="0" err="1"/>
              <a:t>Weijden</a:t>
            </a:r>
            <a:r>
              <a:rPr lang="en-US" dirty="0"/>
              <a:t>, T., De Wit, M. P. T., Frosch, D., </a:t>
            </a:r>
            <a:r>
              <a:rPr lang="en-US" dirty="0" err="1"/>
              <a:t>Légaré</a:t>
            </a:r>
            <a:r>
              <a:rPr lang="en-US" dirty="0"/>
              <a:t>, F., </a:t>
            </a:r>
            <a:r>
              <a:rPr lang="en-US" dirty="0" err="1"/>
              <a:t>Montori</a:t>
            </a:r>
            <a:r>
              <a:rPr lang="en-US" dirty="0"/>
              <a:t>, V. M., Trevena, L., &amp; Elwyn, G. (2012). Shared decision making: really putting patients at the </a:t>
            </a:r>
            <a:r>
              <a:rPr lang="en-US" dirty="0" err="1"/>
              <a:t>centre</a:t>
            </a:r>
            <a:r>
              <a:rPr lang="en-US" dirty="0"/>
              <a:t> of healthcare. </a:t>
            </a:r>
            <a:r>
              <a:rPr lang="en-US" i="1" dirty="0" err="1"/>
              <a:t>Bmj</a:t>
            </a:r>
            <a:r>
              <a:rPr lang="en-US" dirty="0"/>
              <a:t>, </a:t>
            </a:r>
            <a:r>
              <a:rPr lang="en-US" i="1" dirty="0"/>
              <a:t>344</a:t>
            </a:r>
            <a:r>
              <a:rPr lang="en-US" dirty="0"/>
              <a:t>.</a:t>
            </a:r>
          </a:p>
          <a:p>
            <a:endParaRPr lang="en-US" dirty="0"/>
          </a:p>
          <a:p>
            <a:endParaRPr lang="ar-SY" dirty="0"/>
          </a:p>
        </p:txBody>
      </p:sp>
    </p:spTree>
    <p:extLst>
      <p:ext uri="{BB962C8B-B14F-4D97-AF65-F5344CB8AC3E}">
        <p14:creationId xmlns:p14="http://schemas.microsoft.com/office/powerpoint/2010/main" val="2535026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</a:t>
            </a:r>
            <a:r>
              <a:rPr lang="ar-SY" b="1" dirty="0"/>
              <a:t> </a:t>
            </a:r>
            <a:r>
              <a:rPr lang="ar-SY" dirty="0"/>
              <a:t>تقييم الدراسات بشكل نقدي.</a:t>
            </a:r>
            <a:br>
              <a:rPr lang="ar-SY" dirty="0"/>
            </a:br>
            <a:r>
              <a:rPr lang="ar-SY" dirty="0"/>
              <a:t>2) </a:t>
            </a:r>
            <a:r>
              <a:rPr lang="ar-SY" b="1" dirty="0"/>
              <a:t>تعريف مفهوم تطبيق الأدلة العلمية.</a:t>
            </a:r>
            <a:br>
              <a:rPr lang="ar-SY" dirty="0"/>
            </a:br>
            <a:r>
              <a:rPr lang="ar-SY" dirty="0"/>
              <a:t>3) </a:t>
            </a:r>
            <a:r>
              <a:rPr lang="ar-SY" b="1" dirty="0"/>
              <a:t>تعريف مفهوم تقويم مراحل الطب المسند بالدليل. </a:t>
            </a:r>
            <a:br>
              <a:rPr lang="ar-SY" dirty="0"/>
            </a:b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35417513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0CC76-96F9-43B1-9962-97B451F30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طبيق الدليل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3275EE-7BCA-4C88-AC03-EFEC4BB802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الخطوة الرابعة هي الأكثر تعقيدًا، لأنها تتضمن تعديل نتائج الأدلة بحسب الظروف السريرية وقيم المريض الشخصية وتفضيلاته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 </a:t>
            </a:r>
            <a:endParaRPr lang="ar-SY" dirty="0"/>
          </a:p>
          <a:p>
            <a:pPr algn="just" rtl="1"/>
            <a:r>
              <a:rPr lang="ar-SY" dirty="0"/>
              <a:t>خلال هذه العملية يجب مناقشة الدليل مع المريض أثناء الاستشارة السريرية، للسماح بتشكيل تحالف علاجي بين المريض والطبيب. </a:t>
            </a: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C2B58FA-C2CB-46ED-B8EB-FD14A46764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8763" y="3855385"/>
            <a:ext cx="6194473" cy="2637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71116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1C8D7F-8342-4C6A-A7CC-071AEFBCB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طبيق الدليل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BFA7DA-E25D-44FD-8C11-F2987E3547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صنع القرار المشترك على أنه آلية لتقليل عدم تناسق المعلومات والقوة بين المريض والطبيب ، من خلال: </a:t>
            </a:r>
          </a:p>
          <a:p>
            <a:pPr algn="just" rtl="1"/>
            <a:r>
              <a:rPr lang="ar-SY" dirty="0"/>
              <a:t>زيادة معرفة المرضى </a:t>
            </a:r>
          </a:p>
          <a:p>
            <a:pPr algn="just" rtl="1"/>
            <a:r>
              <a:rPr lang="ar-SY" dirty="0"/>
              <a:t>وتعزيز شعورهم بالاستقلالية </a:t>
            </a:r>
          </a:p>
          <a:p>
            <a:pPr algn="just" rtl="1"/>
            <a:r>
              <a:rPr lang="ar-SY" dirty="0"/>
              <a:t>وإشراكهم في اتخاذ القرارات، بقدر ما يرغبون في المشاركة </a:t>
            </a:r>
          </a:p>
          <a:p>
            <a:pPr algn="just" rtl="1"/>
            <a:endParaRPr lang="ar-SY" sz="2000" dirty="0"/>
          </a:p>
          <a:p>
            <a:pPr algn="just" rtl="1"/>
            <a:endParaRPr lang="ar-SY" sz="2000" dirty="0"/>
          </a:p>
          <a:p>
            <a:pPr algn="just" rtl="1"/>
            <a:endParaRPr lang="ar-SY" sz="2000" dirty="0"/>
          </a:p>
          <a:p>
            <a:pPr marL="0" indent="0" algn="just" rtl="1">
              <a:buNone/>
            </a:pPr>
            <a:r>
              <a:rPr lang="en-US" sz="2000" dirty="0"/>
              <a:t>(Charles et al., 1997)</a:t>
            </a:r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E4979AB-7816-4DE5-922E-1E08B6DD8F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303" y="4318963"/>
            <a:ext cx="4518881" cy="2539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80139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5170C-1A13-47D1-8B9B-E05095A3B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طبيق الدليل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230BD5-A175-4F26-AE6F-14A15BD2A5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باعتبار  نموذجًا مثاليًا لمعظم الممارسات الطبية فقد تبنت العديد من البلدان سياسات تدعم تنفيذها ضمن أنظمة الرعاية الصحية الخاصة بهم. </a:t>
            </a:r>
            <a:r>
              <a:rPr lang="en-US" sz="2000" dirty="0"/>
              <a:t>(</a:t>
            </a:r>
            <a:r>
              <a:rPr lang="en-US" sz="2000" dirty="0" err="1"/>
              <a:t>Stiggelbout</a:t>
            </a:r>
            <a:r>
              <a:rPr lang="en-US" sz="2000" dirty="0"/>
              <a:t> et al., 2012)</a:t>
            </a:r>
            <a:endParaRPr lang="ar-SY" dirty="0"/>
          </a:p>
          <a:p>
            <a:pPr algn="just" rtl="1"/>
            <a:r>
              <a:rPr lang="ar-SY" dirty="0"/>
              <a:t>اتخاذ القرار المشترك لا يعني مجرد تزويد المريض </a:t>
            </a:r>
          </a:p>
          <a:p>
            <a:pPr marL="0" indent="0" algn="just" rtl="1">
              <a:buNone/>
            </a:pPr>
            <a:r>
              <a:rPr lang="ar-SY" dirty="0"/>
              <a:t>بالخيارات العلاجية جنبًا إلى جنب مع مزاياها وعيوبها. </a:t>
            </a:r>
          </a:p>
          <a:p>
            <a:pPr marL="0" indent="0" algn="just" rtl="1">
              <a:buNone/>
            </a:pPr>
            <a:r>
              <a:rPr lang="ar-SY" dirty="0"/>
              <a:t>وإنما تعني تقديم هذه الخيارات بالطريقة التي تهم المريض</a:t>
            </a:r>
          </a:p>
          <a:p>
            <a:pPr marL="0" indent="0" algn="just" rtl="1">
              <a:buNone/>
            </a:pPr>
            <a:r>
              <a:rPr lang="ar-SY" dirty="0"/>
              <a:t>وما هو أفضل مسار للعمل </a:t>
            </a:r>
          </a:p>
          <a:p>
            <a:pPr marL="0" indent="0" algn="just" rtl="1">
              <a:buNone/>
            </a:pPr>
            <a:r>
              <a:rPr lang="ar-SY" dirty="0"/>
              <a:t>وكيف يمكن أن يؤثر ذلك على رفاهية المريض.</a:t>
            </a:r>
          </a:p>
          <a:p>
            <a:pPr marL="0" indent="0" algn="just" rtl="1">
              <a:buNone/>
            </a:pPr>
            <a:r>
              <a:rPr lang="en-US" sz="2000" dirty="0"/>
              <a:t>(Greenhalgh et al., 2014)</a:t>
            </a:r>
          </a:p>
          <a:p>
            <a:pPr marL="0" indent="0" algn="just" rtl="1">
              <a:buNone/>
            </a:pPr>
            <a:endParaRPr lang="en-US" sz="2000" dirty="0"/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C9DBAAD-E3AA-4E93-9563-1447C1D940A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15" y="3782412"/>
            <a:ext cx="4381265" cy="29208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69574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B5E6A1-56C9-493D-A456-002CAF83F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قويم عملية الطب المسند بالدليل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2BF006-4389-4D28-A691-727F1CF40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نقوم بتقويم هذه المقاربة بشكل دوري </a:t>
            </a:r>
          </a:p>
          <a:p>
            <a:pPr algn="just" rtl="1"/>
            <a:r>
              <a:rPr lang="ar-SY" dirty="0"/>
              <a:t>وأن نقرر فيما إذا كان هنالك حاجة للتطوير في أي من المراحل الأربعة السابقة. </a:t>
            </a:r>
          </a:p>
          <a:p>
            <a:pPr algn="just" rtl="1"/>
            <a:r>
              <a:rPr lang="ar-SY" dirty="0"/>
              <a:t>حيث نبدأ بسؤال أنفسنا فيما إذا كنا قمنا بصياغة سؤال قابل للحل. </a:t>
            </a:r>
          </a:p>
          <a:p>
            <a:pPr algn="just" rtl="1"/>
            <a:r>
              <a:rPr lang="ar-SY" dirty="0"/>
              <a:t>وفيما إذا قمنا بإيجاد دليل جيد بسرعة.</a:t>
            </a:r>
          </a:p>
          <a:p>
            <a:pPr algn="just" rtl="1"/>
            <a:r>
              <a:rPr lang="ar-SY" dirty="0"/>
              <a:t>وفيما إذا قمنا بتقييم الدليل بشكل فعال.</a:t>
            </a:r>
          </a:p>
          <a:p>
            <a:pPr algn="just" rtl="1"/>
            <a:r>
              <a:rPr lang="ar-SY" dirty="0"/>
              <a:t>وفيما إذا كنا نقوم بدمج الخبرة السريرية </a:t>
            </a:r>
          </a:p>
          <a:p>
            <a:pPr marL="0" indent="0" algn="just" rtl="1">
              <a:buNone/>
            </a:pPr>
            <a:r>
              <a:rPr lang="ar-SY" dirty="0"/>
              <a:t>وقيم المريض مع الدليل بطريقة منطقية مقبولة.</a:t>
            </a:r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endParaRPr lang="ar-SY" sz="2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5B9E960-94AC-4386-A277-3874BC9192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1632" y="3476075"/>
            <a:ext cx="4783015" cy="2690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94616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91337-CFBC-4504-97F0-C63F86797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قويم عملية الطب المسند بالدليل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C01DDE-1831-4291-8805-A2A83A04F4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b="1" dirty="0"/>
              <a:t>جوانب إضافية للتقويم:</a:t>
            </a:r>
          </a:p>
          <a:p>
            <a:pPr algn="just" rtl="1"/>
            <a:r>
              <a:rPr lang="ar-SY" dirty="0"/>
              <a:t>الاستجابة ودرجة الامتثال من جانب المرضى</a:t>
            </a:r>
          </a:p>
          <a:p>
            <a:pPr algn="just" rtl="1"/>
            <a:r>
              <a:rPr lang="ar-SY" dirty="0"/>
              <a:t>وصعوبة التطبيق </a:t>
            </a:r>
          </a:p>
          <a:p>
            <a:pPr algn="just" rtl="1"/>
            <a:r>
              <a:rPr lang="ar-SY" dirty="0"/>
              <a:t>والنتائج السريرية </a:t>
            </a:r>
          </a:p>
          <a:p>
            <a:pPr algn="just" rtl="1"/>
            <a:r>
              <a:rPr lang="ar-SY" dirty="0"/>
              <a:t>وتأثير التطبيق الفعلي والتغييرات التي أحدثتها التجربة في أفكار ومهارات الأطباء.</a:t>
            </a:r>
            <a:endParaRPr lang="en-US" dirty="0"/>
          </a:p>
          <a:p>
            <a:pPr marL="0" indent="0" algn="just" rtl="1">
              <a:buNone/>
            </a:pPr>
            <a:r>
              <a:rPr lang="en-US" sz="2000" dirty="0"/>
              <a:t>(Kang, 2016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0193554-FBFE-4F22-85FC-1D23714C4E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0415" y="4665784"/>
            <a:ext cx="6910754" cy="2220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30668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DA96F-1028-4FD3-8602-023DEA4438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تقويم عملية الطب المسند بالدليل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890F25-C439-4C76-99B4-1AF3024274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وضع آلية للتغذية الراجعة في عملية التطبيق الفعلي للأدلة،</a:t>
            </a:r>
          </a:p>
          <a:p>
            <a:pPr marL="0" indent="0" algn="just" rtl="1">
              <a:buNone/>
            </a:pPr>
            <a:r>
              <a:rPr lang="ar-SY" dirty="0"/>
              <a:t>تمكن الآخرين من أداء العملية بشكل جيد.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Kang, 2016)</a:t>
            </a:r>
          </a:p>
          <a:p>
            <a:pPr algn="just" rtl="1"/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0808CD6-1CBD-45F6-8B90-C112B8C5561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939" y="1506415"/>
            <a:ext cx="3429000" cy="3429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52A2D61-8E4F-4C9D-A4F1-172A2626A5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7940" y="3123823"/>
            <a:ext cx="5814863" cy="3623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8233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2EC54D8-1484-4B31-83FD-9FF1661280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5354" y="211015"/>
            <a:ext cx="8581292" cy="6435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6821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623</Words>
  <Application>Microsoft Office PowerPoint</Application>
  <PresentationFormat>Widescreen</PresentationFormat>
  <Paragraphs>64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تطبيق الدليل</vt:lpstr>
      <vt:lpstr>تطبيق الدليل</vt:lpstr>
      <vt:lpstr>تطبيق الدليل</vt:lpstr>
      <vt:lpstr>تقويم عملية الطب المسند بالدليل</vt:lpstr>
      <vt:lpstr>تقويم عملية الطب المسند بالدليل</vt:lpstr>
      <vt:lpstr>تقويم عملية الطب المسند بالدليل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15</cp:revision>
  <dcterms:created xsi:type="dcterms:W3CDTF">2021-05-07T13:07:52Z</dcterms:created>
  <dcterms:modified xsi:type="dcterms:W3CDTF">2021-06-15T23:51:54Z</dcterms:modified>
</cp:coreProperties>
</file>